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4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453F40-78F3-437C-BF2A-576FB47FAE0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DB7496-E91E-4487-9552-25FB5E9C870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3520D5-3E33-4496-BF5F-454D2A2E85F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360232-FA5D-471F-BDA7-42E12BF5C3C5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94181-D888-4C55-88D9-5E83DC9B040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7"/>
          <p:cNvGrpSpPr/>
          <p:nvPr/>
        </p:nvGrpSpPr>
        <p:grpSpPr>
          <a:xfrm>
            <a:off x="228600" y="457200"/>
            <a:ext cx="8763000" cy="6324600"/>
            <a:chOff x="76200" y="139488"/>
            <a:chExt cx="8915400" cy="6337512"/>
          </a:xfrm>
        </p:grpSpPr>
        <p:sp>
          <p:nvSpPr>
            <p:cNvPr id="4165" name="Rectangle 103"/>
            <p:cNvSpPr>
              <a:spLocks noChangeArrowheads="1"/>
            </p:cNvSpPr>
            <p:nvPr/>
          </p:nvSpPr>
          <p:spPr bwMode="auto">
            <a:xfrm>
              <a:off x="1393825" y="512763"/>
              <a:ext cx="88900" cy="90487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6" name="Rectangle 104"/>
            <p:cNvSpPr>
              <a:spLocks noChangeArrowheads="1"/>
            </p:cNvSpPr>
            <p:nvPr/>
          </p:nvSpPr>
          <p:spPr bwMode="auto">
            <a:xfrm>
              <a:off x="1524000" y="457200"/>
              <a:ext cx="15212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nadsorbed</a:t>
              </a: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erum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Group 108"/>
            <p:cNvGrpSpPr/>
            <p:nvPr/>
          </p:nvGrpSpPr>
          <p:grpSpPr>
            <a:xfrm>
              <a:off x="1189592" y="3050933"/>
              <a:ext cx="7693209" cy="930490"/>
              <a:chOff x="1372028" y="2468546"/>
              <a:chExt cx="7228618" cy="902587"/>
            </a:xfrm>
          </p:grpSpPr>
          <p:sp>
            <p:nvSpPr>
              <p:cNvPr id="110" name="Rectangle 799"/>
              <p:cNvSpPr>
                <a:spLocks noChangeArrowheads="1"/>
              </p:cNvSpPr>
              <p:nvPr/>
            </p:nvSpPr>
            <p:spPr bwMode="auto">
              <a:xfrm rot="16200000">
                <a:off x="1011492" y="2843181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Rectangle 801"/>
              <p:cNvSpPr>
                <a:spLocks noChangeArrowheads="1"/>
              </p:cNvSpPr>
              <p:nvPr/>
            </p:nvSpPr>
            <p:spPr bwMode="auto">
              <a:xfrm rot="16200000">
                <a:off x="1263907" y="2843183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" name="Rectangle 803"/>
              <p:cNvSpPr>
                <a:spLocks noChangeArrowheads="1"/>
              </p:cNvSpPr>
              <p:nvPr/>
            </p:nvSpPr>
            <p:spPr bwMode="auto">
              <a:xfrm rot="16200000">
                <a:off x="1516320" y="28431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Rectangle 805"/>
              <p:cNvSpPr>
                <a:spLocks noChangeArrowheads="1"/>
              </p:cNvSpPr>
              <p:nvPr/>
            </p:nvSpPr>
            <p:spPr bwMode="auto">
              <a:xfrm rot="16200000">
                <a:off x="1770320" y="28431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Rectangle 807"/>
              <p:cNvSpPr>
                <a:spLocks noChangeArrowheads="1"/>
              </p:cNvSpPr>
              <p:nvPr/>
            </p:nvSpPr>
            <p:spPr bwMode="auto">
              <a:xfrm rot="16200000">
                <a:off x="2021145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Rectangle 809"/>
              <p:cNvSpPr>
                <a:spLocks noChangeArrowheads="1"/>
              </p:cNvSpPr>
              <p:nvPr/>
            </p:nvSpPr>
            <p:spPr bwMode="auto">
              <a:xfrm rot="16200000">
                <a:off x="2273559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Rectangle 811"/>
              <p:cNvSpPr>
                <a:spLocks noChangeArrowheads="1"/>
              </p:cNvSpPr>
              <p:nvPr/>
            </p:nvSpPr>
            <p:spPr bwMode="auto">
              <a:xfrm rot="16200000">
                <a:off x="2525969" y="2830670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Rectangle 813"/>
              <p:cNvSpPr>
                <a:spLocks noChangeArrowheads="1"/>
              </p:cNvSpPr>
              <p:nvPr/>
            </p:nvSpPr>
            <p:spPr bwMode="auto">
              <a:xfrm rot="16200000">
                <a:off x="2778382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Rectangle 815"/>
              <p:cNvSpPr>
                <a:spLocks noChangeArrowheads="1"/>
              </p:cNvSpPr>
              <p:nvPr/>
            </p:nvSpPr>
            <p:spPr bwMode="auto">
              <a:xfrm rot="16200000">
                <a:off x="303079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4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Rectangle 817"/>
              <p:cNvSpPr>
                <a:spLocks noChangeArrowheads="1"/>
              </p:cNvSpPr>
              <p:nvPr/>
            </p:nvSpPr>
            <p:spPr bwMode="auto">
              <a:xfrm rot="16200000">
                <a:off x="3281620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Rectangle 819"/>
              <p:cNvSpPr>
                <a:spLocks noChangeArrowheads="1"/>
              </p:cNvSpPr>
              <p:nvPr/>
            </p:nvSpPr>
            <p:spPr bwMode="auto">
              <a:xfrm rot="16200000">
                <a:off x="3534032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ctangle 821"/>
              <p:cNvSpPr>
                <a:spLocks noChangeArrowheads="1"/>
              </p:cNvSpPr>
              <p:nvPr/>
            </p:nvSpPr>
            <p:spPr bwMode="auto">
              <a:xfrm rot="16200000">
                <a:off x="3786446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Rectangle 823"/>
              <p:cNvSpPr>
                <a:spLocks noChangeArrowheads="1"/>
              </p:cNvSpPr>
              <p:nvPr/>
            </p:nvSpPr>
            <p:spPr bwMode="auto">
              <a:xfrm rot="16200000">
                <a:off x="4038860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825"/>
              <p:cNvSpPr>
                <a:spLocks noChangeArrowheads="1"/>
              </p:cNvSpPr>
              <p:nvPr/>
            </p:nvSpPr>
            <p:spPr bwMode="auto">
              <a:xfrm rot="16200000">
                <a:off x="4291271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827"/>
              <p:cNvSpPr>
                <a:spLocks noChangeArrowheads="1"/>
              </p:cNvSpPr>
              <p:nvPr/>
            </p:nvSpPr>
            <p:spPr bwMode="auto">
              <a:xfrm rot="16200000">
                <a:off x="4542097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Rectangle 829"/>
              <p:cNvSpPr>
                <a:spLocks noChangeArrowheads="1"/>
              </p:cNvSpPr>
              <p:nvPr/>
            </p:nvSpPr>
            <p:spPr bwMode="auto">
              <a:xfrm rot="16200000">
                <a:off x="479450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Rectangle 831"/>
              <p:cNvSpPr>
                <a:spLocks noChangeArrowheads="1"/>
              </p:cNvSpPr>
              <p:nvPr/>
            </p:nvSpPr>
            <p:spPr bwMode="auto">
              <a:xfrm rot="16200000">
                <a:off x="5046922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Rectangle 833"/>
              <p:cNvSpPr>
                <a:spLocks noChangeArrowheads="1"/>
              </p:cNvSpPr>
              <p:nvPr/>
            </p:nvSpPr>
            <p:spPr bwMode="auto">
              <a:xfrm rot="16200000">
                <a:off x="529774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Rectangle 835"/>
              <p:cNvSpPr>
                <a:spLocks noChangeArrowheads="1"/>
              </p:cNvSpPr>
              <p:nvPr/>
            </p:nvSpPr>
            <p:spPr bwMode="auto">
              <a:xfrm rot="16200000">
                <a:off x="555174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Rectangle 837"/>
              <p:cNvSpPr>
                <a:spLocks noChangeArrowheads="1"/>
              </p:cNvSpPr>
              <p:nvPr/>
            </p:nvSpPr>
            <p:spPr bwMode="auto">
              <a:xfrm rot="16200000">
                <a:off x="5802571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3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Rectangle 839"/>
              <p:cNvSpPr>
                <a:spLocks noChangeArrowheads="1"/>
              </p:cNvSpPr>
              <p:nvPr/>
            </p:nvSpPr>
            <p:spPr bwMode="auto">
              <a:xfrm rot="16200000">
                <a:off x="6054984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5:05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Rectangle 841"/>
              <p:cNvSpPr>
                <a:spLocks noChangeArrowheads="1"/>
              </p:cNvSpPr>
              <p:nvPr/>
            </p:nvSpPr>
            <p:spPr bwMode="auto">
              <a:xfrm rot="16200000">
                <a:off x="6307397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6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Rectangle 843"/>
              <p:cNvSpPr>
                <a:spLocks noChangeArrowheads="1"/>
              </p:cNvSpPr>
              <p:nvPr/>
            </p:nvSpPr>
            <p:spPr bwMode="auto">
              <a:xfrm rot="16200000">
                <a:off x="655980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1:01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" name="Rectangle 845"/>
              <p:cNvSpPr>
                <a:spLocks noChangeArrowheads="1"/>
              </p:cNvSpPr>
              <p:nvPr/>
            </p:nvSpPr>
            <p:spPr bwMode="auto">
              <a:xfrm rot="16200000">
                <a:off x="6812221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Rectangle 847"/>
              <p:cNvSpPr>
                <a:spLocks noChangeArrowheads="1"/>
              </p:cNvSpPr>
              <p:nvPr/>
            </p:nvSpPr>
            <p:spPr bwMode="auto">
              <a:xfrm rot="16200000">
                <a:off x="7063045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" name="Rectangle 849"/>
              <p:cNvSpPr>
                <a:spLocks noChangeArrowheads="1"/>
              </p:cNvSpPr>
              <p:nvPr/>
            </p:nvSpPr>
            <p:spPr bwMode="auto">
              <a:xfrm rot="16200000">
                <a:off x="731545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" name="Rectangle 851"/>
              <p:cNvSpPr>
                <a:spLocks noChangeArrowheads="1"/>
              </p:cNvSpPr>
              <p:nvPr/>
            </p:nvSpPr>
            <p:spPr bwMode="auto">
              <a:xfrm rot="16200000">
                <a:off x="7567869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" name="Rectangle 853"/>
              <p:cNvSpPr>
                <a:spLocks noChangeArrowheads="1"/>
              </p:cNvSpPr>
              <p:nvPr/>
            </p:nvSpPr>
            <p:spPr bwMode="auto">
              <a:xfrm rot="16200000">
                <a:off x="7820284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" name="Rectangle 855"/>
              <p:cNvSpPr>
                <a:spLocks noChangeArrowheads="1"/>
              </p:cNvSpPr>
              <p:nvPr/>
            </p:nvSpPr>
            <p:spPr bwMode="auto">
              <a:xfrm rot="16200000">
                <a:off x="8072696" y="282908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A1*03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138"/>
            <p:cNvGrpSpPr/>
            <p:nvPr/>
          </p:nvGrpSpPr>
          <p:grpSpPr>
            <a:xfrm>
              <a:off x="1177137" y="2211436"/>
              <a:ext cx="7687066" cy="915954"/>
              <a:chOff x="1494270" y="2855886"/>
              <a:chExt cx="7222846" cy="888487"/>
            </a:xfrm>
          </p:grpSpPr>
          <p:sp>
            <p:nvSpPr>
              <p:cNvPr id="140" name="Rectangle 800"/>
              <p:cNvSpPr>
                <a:spLocks noChangeArrowheads="1"/>
              </p:cNvSpPr>
              <p:nvPr/>
            </p:nvSpPr>
            <p:spPr bwMode="auto">
              <a:xfrm rot="16200000">
                <a:off x="1133734" y="3216423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Rectangle 802"/>
              <p:cNvSpPr>
                <a:spLocks noChangeArrowheads="1"/>
              </p:cNvSpPr>
              <p:nvPr/>
            </p:nvSpPr>
            <p:spPr bwMode="auto">
              <a:xfrm rot="16200000">
                <a:off x="1386146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2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Rectangle 804"/>
              <p:cNvSpPr>
                <a:spLocks noChangeArrowheads="1"/>
              </p:cNvSpPr>
              <p:nvPr/>
            </p:nvSpPr>
            <p:spPr bwMode="auto">
              <a:xfrm rot="16200000">
                <a:off x="1638560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" name="Rectangle 806"/>
              <p:cNvSpPr>
                <a:spLocks noChangeArrowheads="1"/>
              </p:cNvSpPr>
              <p:nvPr/>
            </p:nvSpPr>
            <p:spPr bwMode="auto">
              <a:xfrm rot="16200000">
                <a:off x="1890970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" name="Rectangle 808"/>
              <p:cNvSpPr>
                <a:spLocks noChangeArrowheads="1"/>
              </p:cNvSpPr>
              <p:nvPr/>
            </p:nvSpPr>
            <p:spPr bwMode="auto">
              <a:xfrm rot="16200000">
                <a:off x="2143384" y="3216422"/>
                <a:ext cx="888486" cy="1674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2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" name="Rectangle 810"/>
              <p:cNvSpPr>
                <a:spLocks noChangeArrowheads="1"/>
              </p:cNvSpPr>
              <p:nvPr/>
            </p:nvSpPr>
            <p:spPr bwMode="auto">
              <a:xfrm rot="16200000">
                <a:off x="2455968" y="3277683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QB1*04:01</a:t>
                </a:r>
                <a:endParaRPr kumimoji="0" lang="en-US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" name="Rectangle 812"/>
              <p:cNvSpPr>
                <a:spLocks noChangeArrowheads="1"/>
              </p:cNvSpPr>
              <p:nvPr/>
            </p:nvSpPr>
            <p:spPr bwMode="auto">
              <a:xfrm rot="16200000">
                <a:off x="2708383" y="3276096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2</a:t>
                </a:r>
              </a:p>
            </p:txBody>
          </p:sp>
          <p:sp>
            <p:nvSpPr>
              <p:cNvPr id="147" name="Rectangle 814"/>
              <p:cNvSpPr>
                <a:spLocks noChangeArrowheads="1"/>
              </p:cNvSpPr>
              <p:nvPr/>
            </p:nvSpPr>
            <p:spPr bwMode="auto">
              <a:xfrm rot="16200000">
                <a:off x="2959208" y="3276096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1</a:t>
                </a:r>
              </a:p>
            </p:txBody>
          </p:sp>
          <p:sp>
            <p:nvSpPr>
              <p:cNvPr id="148" name="Rectangle 816"/>
              <p:cNvSpPr>
                <a:spLocks noChangeArrowheads="1"/>
              </p:cNvSpPr>
              <p:nvPr/>
            </p:nvSpPr>
            <p:spPr bwMode="auto">
              <a:xfrm rot="16200000">
                <a:off x="3211621" y="3276096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4:02</a:t>
                </a:r>
              </a:p>
            </p:txBody>
          </p:sp>
          <p:sp>
            <p:nvSpPr>
              <p:cNvPr id="149" name="Rectangle 818"/>
              <p:cNvSpPr>
                <a:spLocks noChangeArrowheads="1"/>
              </p:cNvSpPr>
              <p:nvPr/>
            </p:nvSpPr>
            <p:spPr bwMode="auto">
              <a:xfrm rot="16200000">
                <a:off x="3464034" y="3276443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5:01</a:t>
                </a:r>
              </a:p>
            </p:txBody>
          </p:sp>
          <p:sp>
            <p:nvSpPr>
              <p:cNvPr id="150" name="Rectangle 820"/>
              <p:cNvSpPr>
                <a:spLocks noChangeArrowheads="1"/>
              </p:cNvSpPr>
              <p:nvPr/>
            </p:nvSpPr>
            <p:spPr bwMode="auto">
              <a:xfrm rot="16200000">
                <a:off x="3716445" y="3276442"/>
                <a:ext cx="768137" cy="15905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5:02</a:t>
                </a:r>
              </a:p>
            </p:txBody>
          </p:sp>
          <p:sp>
            <p:nvSpPr>
              <p:cNvPr id="151" name="Rectangle 822"/>
              <p:cNvSpPr>
                <a:spLocks noChangeArrowheads="1"/>
              </p:cNvSpPr>
              <p:nvPr/>
            </p:nvSpPr>
            <p:spPr bwMode="auto">
              <a:xfrm rot="16200000">
                <a:off x="3968858" y="3276442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2</a:t>
                </a:r>
              </a:p>
            </p:txBody>
          </p:sp>
          <p:sp>
            <p:nvSpPr>
              <p:cNvPr id="152" name="Rectangle 824"/>
              <p:cNvSpPr>
                <a:spLocks noChangeArrowheads="1"/>
              </p:cNvSpPr>
              <p:nvPr/>
            </p:nvSpPr>
            <p:spPr bwMode="auto">
              <a:xfrm rot="16200000">
                <a:off x="4219684" y="3276442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2</a:t>
                </a:r>
              </a:p>
            </p:txBody>
          </p:sp>
          <p:sp>
            <p:nvSpPr>
              <p:cNvPr id="153" name="Rectangle 826"/>
              <p:cNvSpPr>
                <a:spLocks noChangeArrowheads="1"/>
              </p:cNvSpPr>
              <p:nvPr/>
            </p:nvSpPr>
            <p:spPr bwMode="auto">
              <a:xfrm rot="16200000">
                <a:off x="4472097" y="3276442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4</a:t>
                </a:r>
              </a:p>
            </p:txBody>
          </p:sp>
          <p:sp>
            <p:nvSpPr>
              <p:cNvPr id="154" name="Rectangle 828"/>
              <p:cNvSpPr>
                <a:spLocks noChangeArrowheads="1"/>
              </p:cNvSpPr>
              <p:nvPr/>
            </p:nvSpPr>
            <p:spPr bwMode="auto">
              <a:xfrm rot="16200000">
                <a:off x="4724508" y="3276442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9</a:t>
                </a:r>
              </a:p>
            </p:txBody>
          </p:sp>
          <p:sp>
            <p:nvSpPr>
              <p:cNvPr id="155" name="Rectangle 830"/>
              <p:cNvSpPr>
                <a:spLocks noChangeArrowheads="1"/>
              </p:cNvSpPr>
              <p:nvPr/>
            </p:nvSpPr>
            <p:spPr bwMode="auto">
              <a:xfrm rot="16200000">
                <a:off x="4976921" y="3276442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1</a:t>
                </a:r>
              </a:p>
            </p:txBody>
          </p:sp>
          <p:sp>
            <p:nvSpPr>
              <p:cNvPr id="156" name="Rectangle 832"/>
              <p:cNvSpPr>
                <a:spLocks noChangeArrowheads="1"/>
              </p:cNvSpPr>
              <p:nvPr/>
            </p:nvSpPr>
            <p:spPr bwMode="auto">
              <a:xfrm rot="16200000">
                <a:off x="5229331" y="3276442"/>
                <a:ext cx="768137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6:03</a:t>
                </a:r>
              </a:p>
            </p:txBody>
          </p:sp>
          <p:sp>
            <p:nvSpPr>
              <p:cNvPr id="157" name="Rectangle 834"/>
              <p:cNvSpPr>
                <a:spLocks noChangeArrowheads="1"/>
              </p:cNvSpPr>
              <p:nvPr/>
            </p:nvSpPr>
            <p:spPr bwMode="auto">
              <a:xfrm rot="16200000">
                <a:off x="5470794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58" name="Rectangle 836"/>
              <p:cNvSpPr>
                <a:spLocks noChangeArrowheads="1"/>
              </p:cNvSpPr>
              <p:nvPr/>
            </p:nvSpPr>
            <p:spPr bwMode="auto">
              <a:xfrm rot="16200000">
                <a:off x="5724794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59" name="Rectangle 838"/>
              <p:cNvSpPr>
                <a:spLocks noChangeArrowheads="1"/>
              </p:cNvSpPr>
              <p:nvPr/>
            </p:nvSpPr>
            <p:spPr bwMode="auto">
              <a:xfrm rot="16200000">
                <a:off x="5977209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60" name="Rectangle 840"/>
              <p:cNvSpPr>
                <a:spLocks noChangeArrowheads="1"/>
              </p:cNvSpPr>
              <p:nvPr/>
            </p:nvSpPr>
            <p:spPr bwMode="auto">
              <a:xfrm rot="16200000">
                <a:off x="6229620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61" name="Rectangle 842"/>
              <p:cNvSpPr>
                <a:spLocks noChangeArrowheads="1"/>
              </p:cNvSpPr>
              <p:nvPr/>
            </p:nvSpPr>
            <p:spPr bwMode="auto">
              <a:xfrm rot="16200000">
                <a:off x="6482034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1</a:t>
                </a:r>
              </a:p>
            </p:txBody>
          </p:sp>
          <p:sp>
            <p:nvSpPr>
              <p:cNvPr id="162" name="Rectangle 844"/>
              <p:cNvSpPr>
                <a:spLocks noChangeArrowheads="1"/>
              </p:cNvSpPr>
              <p:nvPr/>
            </p:nvSpPr>
            <p:spPr bwMode="auto">
              <a:xfrm rot="16200000">
                <a:off x="6732860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63" name="Rectangle 846"/>
              <p:cNvSpPr>
                <a:spLocks noChangeArrowheads="1"/>
              </p:cNvSpPr>
              <p:nvPr/>
            </p:nvSpPr>
            <p:spPr bwMode="auto">
              <a:xfrm rot="16200000">
                <a:off x="6985269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64" name="Rectangle 848"/>
              <p:cNvSpPr>
                <a:spLocks noChangeArrowheads="1"/>
              </p:cNvSpPr>
              <p:nvPr/>
            </p:nvSpPr>
            <p:spPr bwMode="auto">
              <a:xfrm rot="16200000">
                <a:off x="7237683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65" name="Rectangle 850"/>
              <p:cNvSpPr>
                <a:spLocks noChangeArrowheads="1"/>
              </p:cNvSpPr>
              <p:nvPr/>
            </p:nvSpPr>
            <p:spPr bwMode="auto">
              <a:xfrm rot="16200000">
                <a:off x="7490095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2</a:t>
                </a:r>
              </a:p>
            </p:txBody>
          </p:sp>
          <p:sp>
            <p:nvSpPr>
              <p:cNvPr id="166" name="Rectangle 852"/>
              <p:cNvSpPr>
                <a:spLocks noChangeArrowheads="1"/>
              </p:cNvSpPr>
              <p:nvPr/>
            </p:nvSpPr>
            <p:spPr bwMode="auto">
              <a:xfrm rot="16200000">
                <a:off x="7742509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  <p:sp>
            <p:nvSpPr>
              <p:cNvPr id="167" name="Rectangle 854"/>
              <p:cNvSpPr>
                <a:spLocks noChangeArrowheads="1"/>
              </p:cNvSpPr>
              <p:nvPr/>
            </p:nvSpPr>
            <p:spPr bwMode="auto">
              <a:xfrm rot="16200000">
                <a:off x="7993333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  <p:sp>
            <p:nvSpPr>
              <p:cNvPr id="168" name="Rectangle 856"/>
              <p:cNvSpPr>
                <a:spLocks noChangeArrowheads="1"/>
              </p:cNvSpPr>
              <p:nvPr/>
            </p:nvSpPr>
            <p:spPr bwMode="auto">
              <a:xfrm rot="16200000">
                <a:off x="8245746" y="3269714"/>
                <a:ext cx="783686" cy="159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1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DQB1*03:03</a:t>
                </a:r>
              </a:p>
            </p:txBody>
          </p:sp>
        </p:grpSp>
        <p:sp>
          <p:nvSpPr>
            <p:cNvPr id="169" name="TextBox 168"/>
            <p:cNvSpPr txBox="1"/>
            <p:nvPr/>
          </p:nvSpPr>
          <p:spPr>
            <a:xfrm>
              <a:off x="542266" y="2386300"/>
              <a:ext cx="579065" cy="5234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Bet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516445" y="3259363"/>
              <a:ext cx="606061" cy="5234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lpha</a:t>
              </a:r>
            </a:p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a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Rectangle 170"/>
            <p:cNvSpPr/>
            <p:nvPr/>
          </p:nvSpPr>
          <p:spPr>
            <a:xfrm>
              <a:off x="76200" y="152400"/>
              <a:ext cx="8915400" cy="6324600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172" name="Straight Connector 171"/>
            <p:cNvCxnSpPr/>
            <p:nvPr/>
          </p:nvCxnSpPr>
          <p:spPr>
            <a:xfrm>
              <a:off x="76200" y="4267200"/>
              <a:ext cx="8915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Rectangle 190"/>
            <p:cNvSpPr>
              <a:spLocks noChangeArrowheads="1"/>
            </p:cNvSpPr>
            <p:nvPr/>
          </p:nvSpPr>
          <p:spPr bwMode="auto">
            <a:xfrm>
              <a:off x="2396162" y="152400"/>
              <a:ext cx="45969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QB </a:t>
              </a:r>
              <a:r>
                <a:rPr kumimoji="0" lang="en-US" sz="16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pitope</a:t>
              </a:r>
              <a:r>
                <a: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on DQB7,8,9 chains</a:t>
              </a:r>
              <a:endPara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Group 4173"/>
            <p:cNvGrpSpPr/>
            <p:nvPr/>
          </p:nvGrpSpPr>
          <p:grpSpPr>
            <a:xfrm>
              <a:off x="381000" y="275511"/>
              <a:ext cx="8483204" cy="2086690"/>
              <a:chOff x="380155" y="561975"/>
              <a:chExt cx="7864005" cy="1800225"/>
            </a:xfrm>
          </p:grpSpPr>
          <p:cxnSp>
            <p:nvCxnSpPr>
              <p:cNvPr id="175" name="Straight Connector 174"/>
              <p:cNvCxnSpPr/>
              <p:nvPr/>
            </p:nvCxnSpPr>
            <p:spPr>
              <a:xfrm>
                <a:off x="1100493" y="2225060"/>
                <a:ext cx="7141582" cy="0"/>
              </a:xfrm>
              <a:prstGeom prst="line">
                <a:avLst/>
              </a:prstGeom>
              <a:ln>
                <a:solidFill>
                  <a:schemeClr val="bg2">
                    <a:lumMod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22" name="Freeform 61"/>
              <p:cNvSpPr>
                <a:spLocks noEditPoints="1"/>
              </p:cNvSpPr>
              <p:nvPr/>
            </p:nvSpPr>
            <p:spPr bwMode="auto">
              <a:xfrm>
                <a:off x="1109458" y="670035"/>
                <a:ext cx="7132617" cy="1341011"/>
              </a:xfrm>
              <a:custGeom>
                <a:avLst/>
                <a:gdLst>
                  <a:gd name="T0" fmla="*/ 0 w 10264"/>
                  <a:gd name="T1" fmla="*/ 1725 h 1731"/>
                  <a:gd name="T2" fmla="*/ 10264 w 10264"/>
                  <a:gd name="T3" fmla="*/ 1725 h 1731"/>
                  <a:gd name="T4" fmla="*/ 10264 w 10264"/>
                  <a:gd name="T5" fmla="*/ 1731 h 1731"/>
                  <a:gd name="T6" fmla="*/ 0 w 10264"/>
                  <a:gd name="T7" fmla="*/ 1731 h 1731"/>
                  <a:gd name="T8" fmla="*/ 0 w 10264"/>
                  <a:gd name="T9" fmla="*/ 1725 h 1731"/>
                  <a:gd name="T10" fmla="*/ 0 w 10264"/>
                  <a:gd name="T11" fmla="*/ 1380 h 1731"/>
                  <a:gd name="T12" fmla="*/ 10264 w 10264"/>
                  <a:gd name="T13" fmla="*/ 1380 h 1731"/>
                  <a:gd name="T14" fmla="*/ 10264 w 10264"/>
                  <a:gd name="T15" fmla="*/ 1386 h 1731"/>
                  <a:gd name="T16" fmla="*/ 0 w 10264"/>
                  <a:gd name="T17" fmla="*/ 1386 h 1731"/>
                  <a:gd name="T18" fmla="*/ 0 w 10264"/>
                  <a:gd name="T19" fmla="*/ 1380 h 1731"/>
                  <a:gd name="T20" fmla="*/ 0 w 10264"/>
                  <a:gd name="T21" fmla="*/ 1035 h 1731"/>
                  <a:gd name="T22" fmla="*/ 10264 w 10264"/>
                  <a:gd name="T23" fmla="*/ 1035 h 1731"/>
                  <a:gd name="T24" fmla="*/ 10264 w 10264"/>
                  <a:gd name="T25" fmla="*/ 1041 h 1731"/>
                  <a:gd name="T26" fmla="*/ 0 w 10264"/>
                  <a:gd name="T27" fmla="*/ 1041 h 1731"/>
                  <a:gd name="T28" fmla="*/ 0 w 10264"/>
                  <a:gd name="T29" fmla="*/ 1035 h 1731"/>
                  <a:gd name="T30" fmla="*/ 0 w 10264"/>
                  <a:gd name="T31" fmla="*/ 690 h 1731"/>
                  <a:gd name="T32" fmla="*/ 10264 w 10264"/>
                  <a:gd name="T33" fmla="*/ 690 h 1731"/>
                  <a:gd name="T34" fmla="*/ 10264 w 10264"/>
                  <a:gd name="T35" fmla="*/ 696 h 1731"/>
                  <a:gd name="T36" fmla="*/ 0 w 10264"/>
                  <a:gd name="T37" fmla="*/ 696 h 1731"/>
                  <a:gd name="T38" fmla="*/ 0 w 10264"/>
                  <a:gd name="T39" fmla="*/ 690 h 1731"/>
                  <a:gd name="T40" fmla="*/ 0 w 10264"/>
                  <a:gd name="T41" fmla="*/ 345 h 1731"/>
                  <a:gd name="T42" fmla="*/ 10264 w 10264"/>
                  <a:gd name="T43" fmla="*/ 345 h 1731"/>
                  <a:gd name="T44" fmla="*/ 10264 w 10264"/>
                  <a:gd name="T45" fmla="*/ 350 h 1731"/>
                  <a:gd name="T46" fmla="*/ 0 w 10264"/>
                  <a:gd name="T47" fmla="*/ 350 h 1731"/>
                  <a:gd name="T48" fmla="*/ 0 w 10264"/>
                  <a:gd name="T49" fmla="*/ 345 h 1731"/>
                  <a:gd name="T50" fmla="*/ 0 w 10264"/>
                  <a:gd name="T51" fmla="*/ 0 h 1731"/>
                  <a:gd name="T52" fmla="*/ 10264 w 10264"/>
                  <a:gd name="T53" fmla="*/ 0 h 1731"/>
                  <a:gd name="T54" fmla="*/ 10264 w 10264"/>
                  <a:gd name="T55" fmla="*/ 6 h 1731"/>
                  <a:gd name="T56" fmla="*/ 0 w 10264"/>
                  <a:gd name="T57" fmla="*/ 6 h 1731"/>
                  <a:gd name="T58" fmla="*/ 0 w 10264"/>
                  <a:gd name="T59" fmla="*/ 0 h 17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10264" h="1731">
                    <a:moveTo>
                      <a:pt x="0" y="1725"/>
                    </a:moveTo>
                    <a:lnTo>
                      <a:pt x="10264" y="1725"/>
                    </a:lnTo>
                    <a:lnTo>
                      <a:pt x="10264" y="1731"/>
                    </a:lnTo>
                    <a:lnTo>
                      <a:pt x="0" y="1731"/>
                    </a:lnTo>
                    <a:lnTo>
                      <a:pt x="0" y="1725"/>
                    </a:lnTo>
                    <a:close/>
                    <a:moveTo>
                      <a:pt x="0" y="1380"/>
                    </a:moveTo>
                    <a:lnTo>
                      <a:pt x="10264" y="1380"/>
                    </a:lnTo>
                    <a:lnTo>
                      <a:pt x="10264" y="1386"/>
                    </a:lnTo>
                    <a:lnTo>
                      <a:pt x="0" y="1386"/>
                    </a:lnTo>
                    <a:lnTo>
                      <a:pt x="0" y="1380"/>
                    </a:lnTo>
                    <a:close/>
                    <a:moveTo>
                      <a:pt x="0" y="1035"/>
                    </a:moveTo>
                    <a:lnTo>
                      <a:pt x="10264" y="1035"/>
                    </a:lnTo>
                    <a:lnTo>
                      <a:pt x="10264" y="1041"/>
                    </a:lnTo>
                    <a:lnTo>
                      <a:pt x="0" y="1041"/>
                    </a:lnTo>
                    <a:lnTo>
                      <a:pt x="0" y="1035"/>
                    </a:lnTo>
                    <a:close/>
                    <a:moveTo>
                      <a:pt x="0" y="690"/>
                    </a:moveTo>
                    <a:lnTo>
                      <a:pt x="10264" y="690"/>
                    </a:lnTo>
                    <a:lnTo>
                      <a:pt x="10264" y="696"/>
                    </a:lnTo>
                    <a:lnTo>
                      <a:pt x="0" y="696"/>
                    </a:lnTo>
                    <a:lnTo>
                      <a:pt x="0" y="690"/>
                    </a:lnTo>
                    <a:close/>
                    <a:moveTo>
                      <a:pt x="0" y="345"/>
                    </a:moveTo>
                    <a:lnTo>
                      <a:pt x="10264" y="345"/>
                    </a:lnTo>
                    <a:lnTo>
                      <a:pt x="10264" y="350"/>
                    </a:lnTo>
                    <a:lnTo>
                      <a:pt x="0" y="350"/>
                    </a:lnTo>
                    <a:lnTo>
                      <a:pt x="0" y="345"/>
                    </a:lnTo>
                    <a:close/>
                    <a:moveTo>
                      <a:pt x="0" y="0"/>
                    </a:moveTo>
                    <a:lnTo>
                      <a:pt x="10264" y="0"/>
                    </a:lnTo>
                    <a:lnTo>
                      <a:pt x="10264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3" name="Freeform 62"/>
              <p:cNvSpPr>
                <a:spLocks noEditPoints="1"/>
              </p:cNvSpPr>
              <p:nvPr/>
            </p:nvSpPr>
            <p:spPr bwMode="auto">
              <a:xfrm>
                <a:off x="1183814" y="971395"/>
                <a:ext cx="6984601" cy="1304601"/>
              </a:xfrm>
              <a:custGeom>
                <a:avLst/>
                <a:gdLst>
                  <a:gd name="T0" fmla="*/ 141 w 10051"/>
                  <a:gd name="T1" fmla="*/ 1684 h 1684"/>
                  <a:gd name="T2" fmla="*/ 353 w 10051"/>
                  <a:gd name="T3" fmla="*/ 1680 h 1684"/>
                  <a:gd name="T4" fmla="*/ 353 w 10051"/>
                  <a:gd name="T5" fmla="*/ 1684 h 1684"/>
                  <a:gd name="T6" fmla="*/ 849 w 10051"/>
                  <a:gd name="T7" fmla="*/ 1636 h 1684"/>
                  <a:gd name="T8" fmla="*/ 707 w 10051"/>
                  <a:gd name="T9" fmla="*/ 1636 h 1684"/>
                  <a:gd name="T10" fmla="*/ 1203 w 10051"/>
                  <a:gd name="T11" fmla="*/ 1684 h 1684"/>
                  <a:gd name="T12" fmla="*/ 1415 w 10051"/>
                  <a:gd name="T13" fmla="*/ 1683 h 1684"/>
                  <a:gd name="T14" fmla="*/ 1415 w 10051"/>
                  <a:gd name="T15" fmla="*/ 1684 h 1684"/>
                  <a:gd name="T16" fmla="*/ 1911 w 10051"/>
                  <a:gd name="T17" fmla="*/ 1675 h 1684"/>
                  <a:gd name="T18" fmla="*/ 1769 w 10051"/>
                  <a:gd name="T19" fmla="*/ 1675 h 1684"/>
                  <a:gd name="T20" fmla="*/ 2264 w 10051"/>
                  <a:gd name="T21" fmla="*/ 1684 h 1684"/>
                  <a:gd name="T22" fmla="*/ 2477 w 10051"/>
                  <a:gd name="T23" fmla="*/ 1662 h 1684"/>
                  <a:gd name="T24" fmla="*/ 2477 w 10051"/>
                  <a:gd name="T25" fmla="*/ 1684 h 1684"/>
                  <a:gd name="T26" fmla="*/ 2973 w 10051"/>
                  <a:gd name="T27" fmla="*/ 1672 h 1684"/>
                  <a:gd name="T28" fmla="*/ 2831 w 10051"/>
                  <a:gd name="T29" fmla="*/ 1672 h 1684"/>
                  <a:gd name="T30" fmla="*/ 3326 w 10051"/>
                  <a:gd name="T31" fmla="*/ 1684 h 1684"/>
                  <a:gd name="T32" fmla="*/ 3539 w 10051"/>
                  <a:gd name="T33" fmla="*/ 1634 h 1684"/>
                  <a:gd name="T34" fmla="*/ 3539 w 10051"/>
                  <a:gd name="T35" fmla="*/ 1684 h 1684"/>
                  <a:gd name="T36" fmla="*/ 4035 w 10051"/>
                  <a:gd name="T37" fmla="*/ 1636 h 1684"/>
                  <a:gd name="T38" fmla="*/ 3893 w 10051"/>
                  <a:gd name="T39" fmla="*/ 1636 h 1684"/>
                  <a:gd name="T40" fmla="*/ 4388 w 10051"/>
                  <a:gd name="T41" fmla="*/ 1684 h 1684"/>
                  <a:gd name="T42" fmla="*/ 4601 w 10051"/>
                  <a:gd name="T43" fmla="*/ 1595 h 1684"/>
                  <a:gd name="T44" fmla="*/ 4601 w 10051"/>
                  <a:gd name="T45" fmla="*/ 1684 h 1684"/>
                  <a:gd name="T46" fmla="*/ 5096 w 10051"/>
                  <a:gd name="T47" fmla="*/ 1664 h 1684"/>
                  <a:gd name="T48" fmla="*/ 4954 w 10051"/>
                  <a:gd name="T49" fmla="*/ 1664 h 1684"/>
                  <a:gd name="T50" fmla="*/ 5450 w 10051"/>
                  <a:gd name="T51" fmla="*/ 1684 h 1684"/>
                  <a:gd name="T52" fmla="*/ 5663 w 10051"/>
                  <a:gd name="T53" fmla="*/ 1605 h 1684"/>
                  <a:gd name="T54" fmla="*/ 5663 w 10051"/>
                  <a:gd name="T55" fmla="*/ 1684 h 1684"/>
                  <a:gd name="T56" fmla="*/ 6158 w 10051"/>
                  <a:gd name="T57" fmla="*/ 409 h 1684"/>
                  <a:gd name="T58" fmla="*/ 6016 w 10051"/>
                  <a:gd name="T59" fmla="*/ 409 h 1684"/>
                  <a:gd name="T60" fmla="*/ 6511 w 10051"/>
                  <a:gd name="T61" fmla="*/ 1684 h 1684"/>
                  <a:gd name="T62" fmla="*/ 6724 w 10051"/>
                  <a:gd name="T63" fmla="*/ 49 h 1684"/>
                  <a:gd name="T64" fmla="*/ 6724 w 10051"/>
                  <a:gd name="T65" fmla="*/ 1684 h 1684"/>
                  <a:gd name="T66" fmla="*/ 7220 w 10051"/>
                  <a:gd name="T67" fmla="*/ 80 h 1684"/>
                  <a:gd name="T68" fmla="*/ 7078 w 10051"/>
                  <a:gd name="T69" fmla="*/ 80 h 1684"/>
                  <a:gd name="T70" fmla="*/ 7573 w 10051"/>
                  <a:gd name="T71" fmla="*/ 1684 h 1684"/>
                  <a:gd name="T72" fmla="*/ 7786 w 10051"/>
                  <a:gd name="T73" fmla="*/ 569 h 1684"/>
                  <a:gd name="T74" fmla="*/ 7786 w 10051"/>
                  <a:gd name="T75" fmla="*/ 1684 h 1684"/>
                  <a:gd name="T76" fmla="*/ 8281 w 10051"/>
                  <a:gd name="T77" fmla="*/ 534 h 1684"/>
                  <a:gd name="T78" fmla="*/ 8139 w 10051"/>
                  <a:gd name="T79" fmla="*/ 534 h 1684"/>
                  <a:gd name="T80" fmla="*/ 8635 w 10051"/>
                  <a:gd name="T81" fmla="*/ 1684 h 1684"/>
                  <a:gd name="T82" fmla="*/ 8848 w 10051"/>
                  <a:gd name="T83" fmla="*/ 35 h 1684"/>
                  <a:gd name="T84" fmla="*/ 8848 w 10051"/>
                  <a:gd name="T85" fmla="*/ 1684 h 1684"/>
                  <a:gd name="T86" fmla="*/ 9343 w 10051"/>
                  <a:gd name="T87" fmla="*/ 17 h 1684"/>
                  <a:gd name="T88" fmla="*/ 9201 w 10051"/>
                  <a:gd name="T89" fmla="*/ 17 h 1684"/>
                  <a:gd name="T90" fmla="*/ 9696 w 10051"/>
                  <a:gd name="T91" fmla="*/ 1684 h 1684"/>
                  <a:gd name="T92" fmla="*/ 9910 w 10051"/>
                  <a:gd name="T93" fmla="*/ 0 h 1684"/>
                  <a:gd name="T94" fmla="*/ 9910 w 10051"/>
                  <a:gd name="T95" fmla="*/ 1684 h 16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</a:cxnLst>
                <a:rect l="0" t="0" r="r" b="b"/>
                <a:pathLst>
                  <a:path w="10051" h="1684">
                    <a:moveTo>
                      <a:pt x="0" y="1681"/>
                    </a:moveTo>
                    <a:lnTo>
                      <a:pt x="141" y="1681"/>
                    </a:lnTo>
                    <a:lnTo>
                      <a:pt x="141" y="1684"/>
                    </a:lnTo>
                    <a:lnTo>
                      <a:pt x="0" y="1684"/>
                    </a:lnTo>
                    <a:lnTo>
                      <a:pt x="0" y="1681"/>
                    </a:lnTo>
                    <a:close/>
                    <a:moveTo>
                      <a:pt x="353" y="1680"/>
                    </a:moveTo>
                    <a:lnTo>
                      <a:pt x="495" y="1680"/>
                    </a:lnTo>
                    <a:lnTo>
                      <a:pt x="495" y="1684"/>
                    </a:lnTo>
                    <a:lnTo>
                      <a:pt x="353" y="1684"/>
                    </a:lnTo>
                    <a:lnTo>
                      <a:pt x="353" y="1680"/>
                    </a:lnTo>
                    <a:close/>
                    <a:moveTo>
                      <a:pt x="707" y="1636"/>
                    </a:moveTo>
                    <a:lnTo>
                      <a:pt x="849" y="1636"/>
                    </a:lnTo>
                    <a:lnTo>
                      <a:pt x="849" y="1684"/>
                    </a:lnTo>
                    <a:lnTo>
                      <a:pt x="707" y="1684"/>
                    </a:lnTo>
                    <a:lnTo>
                      <a:pt x="707" y="1636"/>
                    </a:lnTo>
                    <a:close/>
                    <a:moveTo>
                      <a:pt x="1062" y="1672"/>
                    </a:moveTo>
                    <a:lnTo>
                      <a:pt x="1203" y="1672"/>
                    </a:lnTo>
                    <a:lnTo>
                      <a:pt x="1203" y="1684"/>
                    </a:lnTo>
                    <a:lnTo>
                      <a:pt x="1062" y="1684"/>
                    </a:lnTo>
                    <a:lnTo>
                      <a:pt x="1062" y="1672"/>
                    </a:lnTo>
                    <a:close/>
                    <a:moveTo>
                      <a:pt x="1415" y="1683"/>
                    </a:moveTo>
                    <a:lnTo>
                      <a:pt x="1557" y="1683"/>
                    </a:lnTo>
                    <a:lnTo>
                      <a:pt x="1557" y="1684"/>
                    </a:lnTo>
                    <a:lnTo>
                      <a:pt x="1415" y="1684"/>
                    </a:lnTo>
                    <a:lnTo>
                      <a:pt x="1415" y="1683"/>
                    </a:lnTo>
                    <a:close/>
                    <a:moveTo>
                      <a:pt x="1769" y="1675"/>
                    </a:moveTo>
                    <a:lnTo>
                      <a:pt x="1911" y="1675"/>
                    </a:lnTo>
                    <a:lnTo>
                      <a:pt x="1911" y="1684"/>
                    </a:lnTo>
                    <a:lnTo>
                      <a:pt x="1769" y="1684"/>
                    </a:lnTo>
                    <a:lnTo>
                      <a:pt x="1769" y="1675"/>
                    </a:lnTo>
                    <a:close/>
                    <a:moveTo>
                      <a:pt x="2123" y="1675"/>
                    </a:moveTo>
                    <a:lnTo>
                      <a:pt x="2264" y="1675"/>
                    </a:lnTo>
                    <a:lnTo>
                      <a:pt x="2264" y="1684"/>
                    </a:lnTo>
                    <a:lnTo>
                      <a:pt x="2123" y="1684"/>
                    </a:lnTo>
                    <a:lnTo>
                      <a:pt x="2123" y="1675"/>
                    </a:lnTo>
                    <a:close/>
                    <a:moveTo>
                      <a:pt x="2477" y="1662"/>
                    </a:moveTo>
                    <a:lnTo>
                      <a:pt x="2619" y="1662"/>
                    </a:lnTo>
                    <a:lnTo>
                      <a:pt x="2619" y="1684"/>
                    </a:lnTo>
                    <a:lnTo>
                      <a:pt x="2477" y="1684"/>
                    </a:lnTo>
                    <a:lnTo>
                      <a:pt x="2477" y="1662"/>
                    </a:lnTo>
                    <a:close/>
                    <a:moveTo>
                      <a:pt x="2831" y="1672"/>
                    </a:moveTo>
                    <a:lnTo>
                      <a:pt x="2973" y="1672"/>
                    </a:lnTo>
                    <a:lnTo>
                      <a:pt x="2973" y="1684"/>
                    </a:lnTo>
                    <a:lnTo>
                      <a:pt x="2831" y="1684"/>
                    </a:lnTo>
                    <a:lnTo>
                      <a:pt x="2831" y="1672"/>
                    </a:lnTo>
                    <a:close/>
                    <a:moveTo>
                      <a:pt x="3185" y="1683"/>
                    </a:moveTo>
                    <a:lnTo>
                      <a:pt x="3326" y="1683"/>
                    </a:lnTo>
                    <a:lnTo>
                      <a:pt x="3326" y="1684"/>
                    </a:lnTo>
                    <a:lnTo>
                      <a:pt x="3185" y="1684"/>
                    </a:lnTo>
                    <a:lnTo>
                      <a:pt x="3185" y="1683"/>
                    </a:lnTo>
                    <a:close/>
                    <a:moveTo>
                      <a:pt x="3539" y="1634"/>
                    </a:moveTo>
                    <a:lnTo>
                      <a:pt x="3680" y="1634"/>
                    </a:lnTo>
                    <a:lnTo>
                      <a:pt x="3680" y="1684"/>
                    </a:lnTo>
                    <a:lnTo>
                      <a:pt x="3539" y="1684"/>
                    </a:lnTo>
                    <a:lnTo>
                      <a:pt x="3539" y="1634"/>
                    </a:lnTo>
                    <a:close/>
                    <a:moveTo>
                      <a:pt x="3893" y="1636"/>
                    </a:moveTo>
                    <a:lnTo>
                      <a:pt x="4035" y="1636"/>
                    </a:lnTo>
                    <a:lnTo>
                      <a:pt x="4035" y="1684"/>
                    </a:lnTo>
                    <a:lnTo>
                      <a:pt x="3893" y="1684"/>
                    </a:lnTo>
                    <a:lnTo>
                      <a:pt x="3893" y="1636"/>
                    </a:lnTo>
                    <a:close/>
                    <a:moveTo>
                      <a:pt x="4247" y="1648"/>
                    </a:moveTo>
                    <a:lnTo>
                      <a:pt x="4388" y="1648"/>
                    </a:lnTo>
                    <a:lnTo>
                      <a:pt x="4388" y="1684"/>
                    </a:lnTo>
                    <a:lnTo>
                      <a:pt x="4247" y="1684"/>
                    </a:lnTo>
                    <a:lnTo>
                      <a:pt x="4247" y="1648"/>
                    </a:lnTo>
                    <a:close/>
                    <a:moveTo>
                      <a:pt x="4601" y="1595"/>
                    </a:moveTo>
                    <a:lnTo>
                      <a:pt x="4742" y="1595"/>
                    </a:lnTo>
                    <a:lnTo>
                      <a:pt x="4742" y="1684"/>
                    </a:lnTo>
                    <a:lnTo>
                      <a:pt x="4601" y="1684"/>
                    </a:lnTo>
                    <a:lnTo>
                      <a:pt x="4601" y="1595"/>
                    </a:lnTo>
                    <a:close/>
                    <a:moveTo>
                      <a:pt x="4954" y="1664"/>
                    </a:moveTo>
                    <a:lnTo>
                      <a:pt x="5096" y="1664"/>
                    </a:lnTo>
                    <a:lnTo>
                      <a:pt x="5096" y="1684"/>
                    </a:lnTo>
                    <a:lnTo>
                      <a:pt x="4954" y="1684"/>
                    </a:lnTo>
                    <a:lnTo>
                      <a:pt x="4954" y="1664"/>
                    </a:lnTo>
                    <a:close/>
                    <a:moveTo>
                      <a:pt x="5308" y="1610"/>
                    </a:moveTo>
                    <a:lnTo>
                      <a:pt x="5450" y="1610"/>
                    </a:lnTo>
                    <a:lnTo>
                      <a:pt x="5450" y="1684"/>
                    </a:lnTo>
                    <a:lnTo>
                      <a:pt x="5308" y="1684"/>
                    </a:lnTo>
                    <a:lnTo>
                      <a:pt x="5308" y="1610"/>
                    </a:lnTo>
                    <a:close/>
                    <a:moveTo>
                      <a:pt x="5663" y="1605"/>
                    </a:moveTo>
                    <a:lnTo>
                      <a:pt x="5804" y="1605"/>
                    </a:lnTo>
                    <a:lnTo>
                      <a:pt x="5804" y="1684"/>
                    </a:lnTo>
                    <a:lnTo>
                      <a:pt x="5663" y="1684"/>
                    </a:lnTo>
                    <a:lnTo>
                      <a:pt x="5663" y="1605"/>
                    </a:lnTo>
                    <a:close/>
                    <a:moveTo>
                      <a:pt x="6016" y="409"/>
                    </a:moveTo>
                    <a:lnTo>
                      <a:pt x="6158" y="409"/>
                    </a:lnTo>
                    <a:lnTo>
                      <a:pt x="6158" y="1684"/>
                    </a:lnTo>
                    <a:lnTo>
                      <a:pt x="6016" y="1684"/>
                    </a:lnTo>
                    <a:lnTo>
                      <a:pt x="6016" y="409"/>
                    </a:lnTo>
                    <a:close/>
                    <a:moveTo>
                      <a:pt x="6370" y="517"/>
                    </a:moveTo>
                    <a:lnTo>
                      <a:pt x="6511" y="517"/>
                    </a:lnTo>
                    <a:lnTo>
                      <a:pt x="6511" y="1684"/>
                    </a:lnTo>
                    <a:lnTo>
                      <a:pt x="6370" y="1684"/>
                    </a:lnTo>
                    <a:lnTo>
                      <a:pt x="6370" y="517"/>
                    </a:lnTo>
                    <a:close/>
                    <a:moveTo>
                      <a:pt x="6724" y="49"/>
                    </a:moveTo>
                    <a:lnTo>
                      <a:pt x="6866" y="49"/>
                    </a:lnTo>
                    <a:lnTo>
                      <a:pt x="6866" y="1684"/>
                    </a:lnTo>
                    <a:lnTo>
                      <a:pt x="6724" y="1684"/>
                    </a:lnTo>
                    <a:lnTo>
                      <a:pt x="6724" y="49"/>
                    </a:lnTo>
                    <a:close/>
                    <a:moveTo>
                      <a:pt x="7078" y="80"/>
                    </a:moveTo>
                    <a:lnTo>
                      <a:pt x="7220" y="80"/>
                    </a:lnTo>
                    <a:lnTo>
                      <a:pt x="7220" y="1684"/>
                    </a:lnTo>
                    <a:lnTo>
                      <a:pt x="7078" y="1684"/>
                    </a:lnTo>
                    <a:lnTo>
                      <a:pt x="7078" y="80"/>
                    </a:lnTo>
                    <a:close/>
                    <a:moveTo>
                      <a:pt x="7432" y="149"/>
                    </a:moveTo>
                    <a:lnTo>
                      <a:pt x="7573" y="149"/>
                    </a:lnTo>
                    <a:lnTo>
                      <a:pt x="7573" y="1684"/>
                    </a:lnTo>
                    <a:lnTo>
                      <a:pt x="7432" y="1684"/>
                    </a:lnTo>
                    <a:lnTo>
                      <a:pt x="7432" y="149"/>
                    </a:lnTo>
                    <a:close/>
                    <a:moveTo>
                      <a:pt x="7786" y="569"/>
                    </a:moveTo>
                    <a:lnTo>
                      <a:pt x="7927" y="569"/>
                    </a:lnTo>
                    <a:lnTo>
                      <a:pt x="7927" y="1684"/>
                    </a:lnTo>
                    <a:lnTo>
                      <a:pt x="7786" y="1684"/>
                    </a:lnTo>
                    <a:lnTo>
                      <a:pt x="7786" y="569"/>
                    </a:lnTo>
                    <a:close/>
                    <a:moveTo>
                      <a:pt x="8139" y="534"/>
                    </a:moveTo>
                    <a:lnTo>
                      <a:pt x="8281" y="534"/>
                    </a:lnTo>
                    <a:lnTo>
                      <a:pt x="8281" y="1684"/>
                    </a:lnTo>
                    <a:lnTo>
                      <a:pt x="8139" y="1684"/>
                    </a:lnTo>
                    <a:lnTo>
                      <a:pt x="8139" y="534"/>
                    </a:lnTo>
                    <a:close/>
                    <a:moveTo>
                      <a:pt x="8494" y="464"/>
                    </a:moveTo>
                    <a:lnTo>
                      <a:pt x="8635" y="464"/>
                    </a:lnTo>
                    <a:lnTo>
                      <a:pt x="8635" y="1684"/>
                    </a:lnTo>
                    <a:lnTo>
                      <a:pt x="8494" y="1684"/>
                    </a:lnTo>
                    <a:lnTo>
                      <a:pt x="8494" y="464"/>
                    </a:lnTo>
                    <a:close/>
                    <a:moveTo>
                      <a:pt x="8848" y="35"/>
                    </a:moveTo>
                    <a:lnTo>
                      <a:pt x="8989" y="35"/>
                    </a:lnTo>
                    <a:lnTo>
                      <a:pt x="8989" y="1684"/>
                    </a:lnTo>
                    <a:lnTo>
                      <a:pt x="8848" y="1684"/>
                    </a:lnTo>
                    <a:lnTo>
                      <a:pt x="8848" y="35"/>
                    </a:lnTo>
                    <a:close/>
                    <a:moveTo>
                      <a:pt x="9201" y="17"/>
                    </a:moveTo>
                    <a:lnTo>
                      <a:pt x="9343" y="17"/>
                    </a:lnTo>
                    <a:lnTo>
                      <a:pt x="9343" y="1684"/>
                    </a:lnTo>
                    <a:lnTo>
                      <a:pt x="9201" y="1684"/>
                    </a:lnTo>
                    <a:lnTo>
                      <a:pt x="9201" y="17"/>
                    </a:lnTo>
                    <a:close/>
                    <a:moveTo>
                      <a:pt x="9555" y="538"/>
                    </a:moveTo>
                    <a:lnTo>
                      <a:pt x="9696" y="538"/>
                    </a:lnTo>
                    <a:lnTo>
                      <a:pt x="9696" y="1684"/>
                    </a:lnTo>
                    <a:lnTo>
                      <a:pt x="9555" y="1684"/>
                    </a:lnTo>
                    <a:lnTo>
                      <a:pt x="9555" y="538"/>
                    </a:lnTo>
                    <a:close/>
                    <a:moveTo>
                      <a:pt x="9910" y="0"/>
                    </a:moveTo>
                    <a:lnTo>
                      <a:pt x="10051" y="0"/>
                    </a:lnTo>
                    <a:lnTo>
                      <a:pt x="10051" y="1684"/>
                    </a:lnTo>
                    <a:lnTo>
                      <a:pt x="9910" y="1684"/>
                    </a:lnTo>
                    <a:lnTo>
                      <a:pt x="9910" y="0"/>
                    </a:lnTo>
                    <a:close/>
                  </a:path>
                </a:pathLst>
              </a:custGeom>
              <a:solidFill>
                <a:srgbClr val="C00000"/>
              </a:solidFill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4" name="Rectangle 63"/>
              <p:cNvSpPr>
                <a:spLocks noChangeArrowheads="1"/>
              </p:cNvSpPr>
              <p:nvPr/>
            </p:nvSpPr>
            <p:spPr bwMode="auto">
              <a:xfrm>
                <a:off x="1107373" y="672359"/>
                <a:ext cx="4169" cy="1603636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5" name="Freeform 64"/>
              <p:cNvSpPr>
                <a:spLocks noEditPoints="1"/>
              </p:cNvSpPr>
              <p:nvPr/>
            </p:nvSpPr>
            <p:spPr bwMode="auto">
              <a:xfrm>
                <a:off x="1086526" y="670035"/>
                <a:ext cx="22932" cy="1607509"/>
              </a:xfrm>
              <a:custGeom>
                <a:avLst/>
                <a:gdLst>
                  <a:gd name="T0" fmla="*/ 0 w 33"/>
                  <a:gd name="T1" fmla="*/ 2070 h 2075"/>
                  <a:gd name="T2" fmla="*/ 33 w 33"/>
                  <a:gd name="T3" fmla="*/ 2070 h 2075"/>
                  <a:gd name="T4" fmla="*/ 33 w 33"/>
                  <a:gd name="T5" fmla="*/ 2075 h 2075"/>
                  <a:gd name="T6" fmla="*/ 0 w 33"/>
                  <a:gd name="T7" fmla="*/ 2075 h 2075"/>
                  <a:gd name="T8" fmla="*/ 0 w 33"/>
                  <a:gd name="T9" fmla="*/ 2070 h 2075"/>
                  <a:gd name="T10" fmla="*/ 0 w 33"/>
                  <a:gd name="T11" fmla="*/ 1725 h 2075"/>
                  <a:gd name="T12" fmla="*/ 33 w 33"/>
                  <a:gd name="T13" fmla="*/ 1725 h 2075"/>
                  <a:gd name="T14" fmla="*/ 33 w 33"/>
                  <a:gd name="T15" fmla="*/ 1731 h 2075"/>
                  <a:gd name="T16" fmla="*/ 0 w 33"/>
                  <a:gd name="T17" fmla="*/ 1731 h 2075"/>
                  <a:gd name="T18" fmla="*/ 0 w 33"/>
                  <a:gd name="T19" fmla="*/ 1725 h 2075"/>
                  <a:gd name="T20" fmla="*/ 0 w 33"/>
                  <a:gd name="T21" fmla="*/ 1380 h 2075"/>
                  <a:gd name="T22" fmla="*/ 33 w 33"/>
                  <a:gd name="T23" fmla="*/ 1380 h 2075"/>
                  <a:gd name="T24" fmla="*/ 33 w 33"/>
                  <a:gd name="T25" fmla="*/ 1386 h 2075"/>
                  <a:gd name="T26" fmla="*/ 0 w 33"/>
                  <a:gd name="T27" fmla="*/ 1386 h 2075"/>
                  <a:gd name="T28" fmla="*/ 0 w 33"/>
                  <a:gd name="T29" fmla="*/ 1380 h 2075"/>
                  <a:gd name="T30" fmla="*/ 0 w 33"/>
                  <a:gd name="T31" fmla="*/ 1035 h 2075"/>
                  <a:gd name="T32" fmla="*/ 33 w 33"/>
                  <a:gd name="T33" fmla="*/ 1035 h 2075"/>
                  <a:gd name="T34" fmla="*/ 33 w 33"/>
                  <a:gd name="T35" fmla="*/ 1041 h 2075"/>
                  <a:gd name="T36" fmla="*/ 0 w 33"/>
                  <a:gd name="T37" fmla="*/ 1041 h 2075"/>
                  <a:gd name="T38" fmla="*/ 0 w 33"/>
                  <a:gd name="T39" fmla="*/ 1035 h 2075"/>
                  <a:gd name="T40" fmla="*/ 0 w 33"/>
                  <a:gd name="T41" fmla="*/ 690 h 2075"/>
                  <a:gd name="T42" fmla="*/ 33 w 33"/>
                  <a:gd name="T43" fmla="*/ 690 h 2075"/>
                  <a:gd name="T44" fmla="*/ 33 w 33"/>
                  <a:gd name="T45" fmla="*/ 696 h 2075"/>
                  <a:gd name="T46" fmla="*/ 0 w 33"/>
                  <a:gd name="T47" fmla="*/ 696 h 2075"/>
                  <a:gd name="T48" fmla="*/ 0 w 33"/>
                  <a:gd name="T49" fmla="*/ 690 h 2075"/>
                  <a:gd name="T50" fmla="*/ 0 w 33"/>
                  <a:gd name="T51" fmla="*/ 345 h 2075"/>
                  <a:gd name="T52" fmla="*/ 33 w 33"/>
                  <a:gd name="T53" fmla="*/ 345 h 2075"/>
                  <a:gd name="T54" fmla="*/ 33 w 33"/>
                  <a:gd name="T55" fmla="*/ 350 h 2075"/>
                  <a:gd name="T56" fmla="*/ 0 w 33"/>
                  <a:gd name="T57" fmla="*/ 350 h 2075"/>
                  <a:gd name="T58" fmla="*/ 0 w 33"/>
                  <a:gd name="T59" fmla="*/ 345 h 2075"/>
                  <a:gd name="T60" fmla="*/ 0 w 33"/>
                  <a:gd name="T61" fmla="*/ 0 h 2075"/>
                  <a:gd name="T62" fmla="*/ 33 w 33"/>
                  <a:gd name="T63" fmla="*/ 0 h 2075"/>
                  <a:gd name="T64" fmla="*/ 33 w 33"/>
                  <a:gd name="T65" fmla="*/ 6 h 2075"/>
                  <a:gd name="T66" fmla="*/ 0 w 33"/>
                  <a:gd name="T67" fmla="*/ 6 h 2075"/>
                  <a:gd name="T68" fmla="*/ 0 w 33"/>
                  <a:gd name="T69" fmla="*/ 0 h 20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33" h="2075">
                    <a:moveTo>
                      <a:pt x="0" y="2070"/>
                    </a:moveTo>
                    <a:lnTo>
                      <a:pt x="33" y="2070"/>
                    </a:lnTo>
                    <a:lnTo>
                      <a:pt x="33" y="2075"/>
                    </a:lnTo>
                    <a:lnTo>
                      <a:pt x="0" y="2075"/>
                    </a:lnTo>
                    <a:lnTo>
                      <a:pt x="0" y="2070"/>
                    </a:lnTo>
                    <a:close/>
                    <a:moveTo>
                      <a:pt x="0" y="1725"/>
                    </a:moveTo>
                    <a:lnTo>
                      <a:pt x="33" y="1725"/>
                    </a:lnTo>
                    <a:lnTo>
                      <a:pt x="33" y="1731"/>
                    </a:lnTo>
                    <a:lnTo>
                      <a:pt x="0" y="1731"/>
                    </a:lnTo>
                    <a:lnTo>
                      <a:pt x="0" y="1725"/>
                    </a:lnTo>
                    <a:close/>
                    <a:moveTo>
                      <a:pt x="0" y="1380"/>
                    </a:moveTo>
                    <a:lnTo>
                      <a:pt x="33" y="1380"/>
                    </a:lnTo>
                    <a:lnTo>
                      <a:pt x="33" y="1386"/>
                    </a:lnTo>
                    <a:lnTo>
                      <a:pt x="0" y="1386"/>
                    </a:lnTo>
                    <a:lnTo>
                      <a:pt x="0" y="1380"/>
                    </a:lnTo>
                    <a:close/>
                    <a:moveTo>
                      <a:pt x="0" y="1035"/>
                    </a:moveTo>
                    <a:lnTo>
                      <a:pt x="33" y="1035"/>
                    </a:lnTo>
                    <a:lnTo>
                      <a:pt x="33" y="1041"/>
                    </a:lnTo>
                    <a:lnTo>
                      <a:pt x="0" y="1041"/>
                    </a:lnTo>
                    <a:lnTo>
                      <a:pt x="0" y="1035"/>
                    </a:lnTo>
                    <a:close/>
                    <a:moveTo>
                      <a:pt x="0" y="690"/>
                    </a:moveTo>
                    <a:lnTo>
                      <a:pt x="33" y="690"/>
                    </a:lnTo>
                    <a:lnTo>
                      <a:pt x="33" y="696"/>
                    </a:lnTo>
                    <a:lnTo>
                      <a:pt x="0" y="696"/>
                    </a:lnTo>
                    <a:lnTo>
                      <a:pt x="0" y="690"/>
                    </a:lnTo>
                    <a:close/>
                    <a:moveTo>
                      <a:pt x="0" y="345"/>
                    </a:moveTo>
                    <a:lnTo>
                      <a:pt x="33" y="345"/>
                    </a:lnTo>
                    <a:lnTo>
                      <a:pt x="33" y="350"/>
                    </a:lnTo>
                    <a:lnTo>
                      <a:pt x="0" y="350"/>
                    </a:lnTo>
                    <a:lnTo>
                      <a:pt x="0" y="345"/>
                    </a:lnTo>
                    <a:close/>
                    <a:moveTo>
                      <a:pt x="0" y="0"/>
                    </a:moveTo>
                    <a:lnTo>
                      <a:pt x="33" y="0"/>
                    </a:lnTo>
                    <a:lnTo>
                      <a:pt x="33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6" name="Rectangle 65"/>
              <p:cNvSpPr>
                <a:spLocks noChangeArrowheads="1"/>
              </p:cNvSpPr>
              <p:nvPr/>
            </p:nvSpPr>
            <p:spPr bwMode="auto">
              <a:xfrm>
                <a:off x="1109458" y="2273671"/>
                <a:ext cx="7132617" cy="3873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7" name="Freeform 66"/>
              <p:cNvSpPr>
                <a:spLocks noEditPoints="1"/>
              </p:cNvSpPr>
              <p:nvPr/>
            </p:nvSpPr>
            <p:spPr bwMode="auto">
              <a:xfrm>
                <a:off x="1107373" y="2275995"/>
                <a:ext cx="7136787" cy="26340"/>
              </a:xfrm>
              <a:custGeom>
                <a:avLst/>
                <a:gdLst>
                  <a:gd name="T0" fmla="*/ 0 w 10270"/>
                  <a:gd name="T1" fmla="*/ 34 h 34"/>
                  <a:gd name="T2" fmla="*/ 360 w 10270"/>
                  <a:gd name="T3" fmla="*/ 0 h 34"/>
                  <a:gd name="T4" fmla="*/ 355 w 10270"/>
                  <a:gd name="T5" fmla="*/ 0 h 34"/>
                  <a:gd name="T6" fmla="*/ 715 w 10270"/>
                  <a:gd name="T7" fmla="*/ 34 h 34"/>
                  <a:gd name="T8" fmla="*/ 715 w 10270"/>
                  <a:gd name="T9" fmla="*/ 0 h 34"/>
                  <a:gd name="T10" fmla="*/ 1062 w 10270"/>
                  <a:gd name="T11" fmla="*/ 34 h 34"/>
                  <a:gd name="T12" fmla="*/ 1422 w 10270"/>
                  <a:gd name="T13" fmla="*/ 0 h 34"/>
                  <a:gd name="T14" fmla="*/ 1416 w 10270"/>
                  <a:gd name="T15" fmla="*/ 0 h 34"/>
                  <a:gd name="T16" fmla="*/ 1776 w 10270"/>
                  <a:gd name="T17" fmla="*/ 34 h 34"/>
                  <a:gd name="T18" fmla="*/ 1776 w 10270"/>
                  <a:gd name="T19" fmla="*/ 0 h 34"/>
                  <a:gd name="T20" fmla="*/ 2124 w 10270"/>
                  <a:gd name="T21" fmla="*/ 34 h 34"/>
                  <a:gd name="T22" fmla="*/ 2484 w 10270"/>
                  <a:gd name="T23" fmla="*/ 0 h 34"/>
                  <a:gd name="T24" fmla="*/ 2478 w 10270"/>
                  <a:gd name="T25" fmla="*/ 0 h 34"/>
                  <a:gd name="T26" fmla="*/ 2838 w 10270"/>
                  <a:gd name="T27" fmla="*/ 34 h 34"/>
                  <a:gd name="T28" fmla="*/ 2838 w 10270"/>
                  <a:gd name="T29" fmla="*/ 0 h 34"/>
                  <a:gd name="T30" fmla="*/ 3186 w 10270"/>
                  <a:gd name="T31" fmla="*/ 34 h 34"/>
                  <a:gd name="T32" fmla="*/ 3546 w 10270"/>
                  <a:gd name="T33" fmla="*/ 0 h 34"/>
                  <a:gd name="T34" fmla="*/ 3540 w 10270"/>
                  <a:gd name="T35" fmla="*/ 0 h 34"/>
                  <a:gd name="T36" fmla="*/ 3900 w 10270"/>
                  <a:gd name="T37" fmla="*/ 34 h 34"/>
                  <a:gd name="T38" fmla="*/ 3900 w 10270"/>
                  <a:gd name="T39" fmla="*/ 0 h 34"/>
                  <a:gd name="T40" fmla="*/ 4247 w 10270"/>
                  <a:gd name="T41" fmla="*/ 34 h 34"/>
                  <a:gd name="T42" fmla="*/ 4607 w 10270"/>
                  <a:gd name="T43" fmla="*/ 0 h 34"/>
                  <a:gd name="T44" fmla="*/ 4602 w 10270"/>
                  <a:gd name="T45" fmla="*/ 0 h 34"/>
                  <a:gd name="T46" fmla="*/ 4962 w 10270"/>
                  <a:gd name="T47" fmla="*/ 34 h 34"/>
                  <a:gd name="T48" fmla="*/ 4962 w 10270"/>
                  <a:gd name="T49" fmla="*/ 0 h 34"/>
                  <a:gd name="T50" fmla="*/ 5309 w 10270"/>
                  <a:gd name="T51" fmla="*/ 34 h 34"/>
                  <a:gd name="T52" fmla="*/ 5669 w 10270"/>
                  <a:gd name="T53" fmla="*/ 0 h 34"/>
                  <a:gd name="T54" fmla="*/ 5663 w 10270"/>
                  <a:gd name="T55" fmla="*/ 0 h 34"/>
                  <a:gd name="T56" fmla="*/ 6023 w 10270"/>
                  <a:gd name="T57" fmla="*/ 34 h 34"/>
                  <a:gd name="T58" fmla="*/ 6023 w 10270"/>
                  <a:gd name="T59" fmla="*/ 0 h 34"/>
                  <a:gd name="T60" fmla="*/ 6371 w 10270"/>
                  <a:gd name="T61" fmla="*/ 34 h 34"/>
                  <a:gd name="T62" fmla="*/ 6731 w 10270"/>
                  <a:gd name="T63" fmla="*/ 0 h 34"/>
                  <a:gd name="T64" fmla="*/ 6725 w 10270"/>
                  <a:gd name="T65" fmla="*/ 0 h 34"/>
                  <a:gd name="T66" fmla="*/ 7085 w 10270"/>
                  <a:gd name="T67" fmla="*/ 34 h 34"/>
                  <a:gd name="T68" fmla="*/ 7085 w 10270"/>
                  <a:gd name="T69" fmla="*/ 0 h 34"/>
                  <a:gd name="T70" fmla="*/ 7432 w 10270"/>
                  <a:gd name="T71" fmla="*/ 34 h 34"/>
                  <a:gd name="T72" fmla="*/ 7792 w 10270"/>
                  <a:gd name="T73" fmla="*/ 0 h 34"/>
                  <a:gd name="T74" fmla="*/ 7787 w 10270"/>
                  <a:gd name="T75" fmla="*/ 0 h 34"/>
                  <a:gd name="T76" fmla="*/ 8147 w 10270"/>
                  <a:gd name="T77" fmla="*/ 34 h 34"/>
                  <a:gd name="T78" fmla="*/ 8147 w 10270"/>
                  <a:gd name="T79" fmla="*/ 0 h 34"/>
                  <a:gd name="T80" fmla="*/ 8494 w 10270"/>
                  <a:gd name="T81" fmla="*/ 34 h 34"/>
                  <a:gd name="T82" fmla="*/ 8854 w 10270"/>
                  <a:gd name="T83" fmla="*/ 0 h 34"/>
                  <a:gd name="T84" fmla="*/ 8848 w 10270"/>
                  <a:gd name="T85" fmla="*/ 0 h 34"/>
                  <a:gd name="T86" fmla="*/ 9208 w 10270"/>
                  <a:gd name="T87" fmla="*/ 34 h 34"/>
                  <a:gd name="T88" fmla="*/ 9208 w 10270"/>
                  <a:gd name="T89" fmla="*/ 0 h 34"/>
                  <a:gd name="T90" fmla="*/ 9556 w 10270"/>
                  <a:gd name="T91" fmla="*/ 34 h 34"/>
                  <a:gd name="T92" fmla="*/ 9916 w 10270"/>
                  <a:gd name="T93" fmla="*/ 0 h 34"/>
                  <a:gd name="T94" fmla="*/ 9910 w 10270"/>
                  <a:gd name="T95" fmla="*/ 0 h 34"/>
                  <a:gd name="T96" fmla="*/ 10270 w 10270"/>
                  <a:gd name="T97" fmla="*/ 34 h 34"/>
                  <a:gd name="T98" fmla="*/ 10270 w 10270"/>
                  <a:gd name="T99" fmla="*/ 0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10270" h="34">
                    <a:moveTo>
                      <a:pt x="6" y="0"/>
                    </a:moveTo>
                    <a:lnTo>
                      <a:pt x="6" y="34"/>
                    </a:lnTo>
                    <a:lnTo>
                      <a:pt x="0" y="34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360" y="0"/>
                    </a:moveTo>
                    <a:lnTo>
                      <a:pt x="360" y="34"/>
                    </a:lnTo>
                    <a:lnTo>
                      <a:pt x="355" y="34"/>
                    </a:lnTo>
                    <a:lnTo>
                      <a:pt x="355" y="0"/>
                    </a:lnTo>
                    <a:lnTo>
                      <a:pt x="360" y="0"/>
                    </a:lnTo>
                    <a:close/>
                    <a:moveTo>
                      <a:pt x="715" y="0"/>
                    </a:moveTo>
                    <a:lnTo>
                      <a:pt x="715" y="34"/>
                    </a:lnTo>
                    <a:lnTo>
                      <a:pt x="709" y="34"/>
                    </a:lnTo>
                    <a:lnTo>
                      <a:pt x="709" y="0"/>
                    </a:lnTo>
                    <a:lnTo>
                      <a:pt x="715" y="0"/>
                    </a:lnTo>
                    <a:close/>
                    <a:moveTo>
                      <a:pt x="1068" y="0"/>
                    </a:moveTo>
                    <a:lnTo>
                      <a:pt x="1068" y="34"/>
                    </a:lnTo>
                    <a:lnTo>
                      <a:pt x="1062" y="34"/>
                    </a:lnTo>
                    <a:lnTo>
                      <a:pt x="1062" y="0"/>
                    </a:lnTo>
                    <a:lnTo>
                      <a:pt x="1068" y="0"/>
                    </a:lnTo>
                    <a:close/>
                    <a:moveTo>
                      <a:pt x="1422" y="0"/>
                    </a:moveTo>
                    <a:lnTo>
                      <a:pt x="1422" y="34"/>
                    </a:lnTo>
                    <a:lnTo>
                      <a:pt x="1416" y="34"/>
                    </a:lnTo>
                    <a:lnTo>
                      <a:pt x="1416" y="0"/>
                    </a:lnTo>
                    <a:lnTo>
                      <a:pt x="1422" y="0"/>
                    </a:lnTo>
                    <a:close/>
                    <a:moveTo>
                      <a:pt x="1776" y="0"/>
                    </a:moveTo>
                    <a:lnTo>
                      <a:pt x="1776" y="34"/>
                    </a:lnTo>
                    <a:lnTo>
                      <a:pt x="1771" y="34"/>
                    </a:lnTo>
                    <a:lnTo>
                      <a:pt x="1771" y="0"/>
                    </a:lnTo>
                    <a:lnTo>
                      <a:pt x="1776" y="0"/>
                    </a:lnTo>
                    <a:close/>
                    <a:moveTo>
                      <a:pt x="2130" y="0"/>
                    </a:moveTo>
                    <a:lnTo>
                      <a:pt x="2130" y="34"/>
                    </a:lnTo>
                    <a:lnTo>
                      <a:pt x="2124" y="34"/>
                    </a:lnTo>
                    <a:lnTo>
                      <a:pt x="2124" y="0"/>
                    </a:lnTo>
                    <a:lnTo>
                      <a:pt x="2130" y="0"/>
                    </a:lnTo>
                    <a:close/>
                    <a:moveTo>
                      <a:pt x="2484" y="0"/>
                    </a:moveTo>
                    <a:lnTo>
                      <a:pt x="2484" y="34"/>
                    </a:lnTo>
                    <a:lnTo>
                      <a:pt x="2478" y="34"/>
                    </a:lnTo>
                    <a:lnTo>
                      <a:pt x="2478" y="0"/>
                    </a:lnTo>
                    <a:lnTo>
                      <a:pt x="2484" y="0"/>
                    </a:lnTo>
                    <a:close/>
                    <a:moveTo>
                      <a:pt x="2838" y="0"/>
                    </a:moveTo>
                    <a:lnTo>
                      <a:pt x="2838" y="34"/>
                    </a:lnTo>
                    <a:lnTo>
                      <a:pt x="2832" y="34"/>
                    </a:lnTo>
                    <a:lnTo>
                      <a:pt x="2832" y="0"/>
                    </a:lnTo>
                    <a:lnTo>
                      <a:pt x="2838" y="0"/>
                    </a:lnTo>
                    <a:close/>
                    <a:moveTo>
                      <a:pt x="3191" y="0"/>
                    </a:moveTo>
                    <a:lnTo>
                      <a:pt x="3191" y="34"/>
                    </a:lnTo>
                    <a:lnTo>
                      <a:pt x="3186" y="34"/>
                    </a:lnTo>
                    <a:lnTo>
                      <a:pt x="3186" y="0"/>
                    </a:lnTo>
                    <a:lnTo>
                      <a:pt x="3191" y="0"/>
                    </a:lnTo>
                    <a:close/>
                    <a:moveTo>
                      <a:pt x="3546" y="0"/>
                    </a:moveTo>
                    <a:lnTo>
                      <a:pt x="3546" y="34"/>
                    </a:lnTo>
                    <a:lnTo>
                      <a:pt x="3540" y="34"/>
                    </a:lnTo>
                    <a:lnTo>
                      <a:pt x="3540" y="0"/>
                    </a:lnTo>
                    <a:lnTo>
                      <a:pt x="3546" y="0"/>
                    </a:lnTo>
                    <a:close/>
                    <a:moveTo>
                      <a:pt x="3900" y="0"/>
                    </a:moveTo>
                    <a:lnTo>
                      <a:pt x="3900" y="34"/>
                    </a:lnTo>
                    <a:lnTo>
                      <a:pt x="3894" y="34"/>
                    </a:lnTo>
                    <a:lnTo>
                      <a:pt x="3894" y="0"/>
                    </a:lnTo>
                    <a:lnTo>
                      <a:pt x="3900" y="0"/>
                    </a:lnTo>
                    <a:close/>
                    <a:moveTo>
                      <a:pt x="4253" y="0"/>
                    </a:moveTo>
                    <a:lnTo>
                      <a:pt x="4253" y="34"/>
                    </a:lnTo>
                    <a:lnTo>
                      <a:pt x="4247" y="34"/>
                    </a:lnTo>
                    <a:lnTo>
                      <a:pt x="4247" y="0"/>
                    </a:lnTo>
                    <a:lnTo>
                      <a:pt x="4253" y="0"/>
                    </a:lnTo>
                    <a:close/>
                    <a:moveTo>
                      <a:pt x="4607" y="0"/>
                    </a:moveTo>
                    <a:lnTo>
                      <a:pt x="4607" y="34"/>
                    </a:lnTo>
                    <a:lnTo>
                      <a:pt x="4602" y="34"/>
                    </a:lnTo>
                    <a:lnTo>
                      <a:pt x="4602" y="0"/>
                    </a:lnTo>
                    <a:lnTo>
                      <a:pt x="4607" y="0"/>
                    </a:lnTo>
                    <a:close/>
                    <a:moveTo>
                      <a:pt x="4962" y="0"/>
                    </a:moveTo>
                    <a:lnTo>
                      <a:pt x="4962" y="34"/>
                    </a:lnTo>
                    <a:lnTo>
                      <a:pt x="4956" y="34"/>
                    </a:lnTo>
                    <a:lnTo>
                      <a:pt x="4956" y="0"/>
                    </a:lnTo>
                    <a:lnTo>
                      <a:pt x="4962" y="0"/>
                    </a:lnTo>
                    <a:close/>
                    <a:moveTo>
                      <a:pt x="5315" y="0"/>
                    </a:moveTo>
                    <a:lnTo>
                      <a:pt x="5315" y="34"/>
                    </a:lnTo>
                    <a:lnTo>
                      <a:pt x="5309" y="34"/>
                    </a:lnTo>
                    <a:lnTo>
                      <a:pt x="5309" y="0"/>
                    </a:lnTo>
                    <a:lnTo>
                      <a:pt x="5315" y="0"/>
                    </a:lnTo>
                    <a:close/>
                    <a:moveTo>
                      <a:pt x="5669" y="0"/>
                    </a:moveTo>
                    <a:lnTo>
                      <a:pt x="5669" y="34"/>
                    </a:lnTo>
                    <a:lnTo>
                      <a:pt x="5663" y="34"/>
                    </a:lnTo>
                    <a:lnTo>
                      <a:pt x="5663" y="0"/>
                    </a:lnTo>
                    <a:lnTo>
                      <a:pt x="5669" y="0"/>
                    </a:lnTo>
                    <a:close/>
                    <a:moveTo>
                      <a:pt x="6023" y="0"/>
                    </a:moveTo>
                    <a:lnTo>
                      <a:pt x="6023" y="34"/>
                    </a:lnTo>
                    <a:lnTo>
                      <a:pt x="6017" y="34"/>
                    </a:lnTo>
                    <a:lnTo>
                      <a:pt x="6017" y="0"/>
                    </a:lnTo>
                    <a:lnTo>
                      <a:pt x="6023" y="0"/>
                    </a:lnTo>
                    <a:close/>
                    <a:moveTo>
                      <a:pt x="6377" y="0"/>
                    </a:moveTo>
                    <a:lnTo>
                      <a:pt x="6377" y="34"/>
                    </a:lnTo>
                    <a:lnTo>
                      <a:pt x="6371" y="34"/>
                    </a:lnTo>
                    <a:lnTo>
                      <a:pt x="6371" y="0"/>
                    </a:lnTo>
                    <a:lnTo>
                      <a:pt x="6377" y="0"/>
                    </a:lnTo>
                    <a:close/>
                    <a:moveTo>
                      <a:pt x="6731" y="0"/>
                    </a:moveTo>
                    <a:lnTo>
                      <a:pt x="6731" y="34"/>
                    </a:lnTo>
                    <a:lnTo>
                      <a:pt x="6725" y="34"/>
                    </a:lnTo>
                    <a:lnTo>
                      <a:pt x="6725" y="0"/>
                    </a:lnTo>
                    <a:lnTo>
                      <a:pt x="6731" y="0"/>
                    </a:lnTo>
                    <a:close/>
                    <a:moveTo>
                      <a:pt x="7085" y="0"/>
                    </a:moveTo>
                    <a:lnTo>
                      <a:pt x="7085" y="34"/>
                    </a:lnTo>
                    <a:lnTo>
                      <a:pt x="7079" y="34"/>
                    </a:lnTo>
                    <a:lnTo>
                      <a:pt x="7079" y="0"/>
                    </a:lnTo>
                    <a:lnTo>
                      <a:pt x="7085" y="0"/>
                    </a:lnTo>
                    <a:close/>
                    <a:moveTo>
                      <a:pt x="7438" y="0"/>
                    </a:moveTo>
                    <a:lnTo>
                      <a:pt x="7438" y="34"/>
                    </a:lnTo>
                    <a:lnTo>
                      <a:pt x="7432" y="34"/>
                    </a:lnTo>
                    <a:lnTo>
                      <a:pt x="7432" y="0"/>
                    </a:lnTo>
                    <a:lnTo>
                      <a:pt x="7438" y="0"/>
                    </a:lnTo>
                    <a:close/>
                    <a:moveTo>
                      <a:pt x="7792" y="0"/>
                    </a:moveTo>
                    <a:lnTo>
                      <a:pt x="7792" y="34"/>
                    </a:lnTo>
                    <a:lnTo>
                      <a:pt x="7787" y="34"/>
                    </a:lnTo>
                    <a:lnTo>
                      <a:pt x="7787" y="0"/>
                    </a:lnTo>
                    <a:lnTo>
                      <a:pt x="7792" y="0"/>
                    </a:lnTo>
                    <a:close/>
                    <a:moveTo>
                      <a:pt x="8147" y="0"/>
                    </a:moveTo>
                    <a:lnTo>
                      <a:pt x="8147" y="34"/>
                    </a:lnTo>
                    <a:lnTo>
                      <a:pt x="8141" y="34"/>
                    </a:lnTo>
                    <a:lnTo>
                      <a:pt x="8141" y="0"/>
                    </a:lnTo>
                    <a:lnTo>
                      <a:pt x="8147" y="0"/>
                    </a:lnTo>
                    <a:close/>
                    <a:moveTo>
                      <a:pt x="8500" y="0"/>
                    </a:moveTo>
                    <a:lnTo>
                      <a:pt x="8500" y="34"/>
                    </a:lnTo>
                    <a:lnTo>
                      <a:pt x="8494" y="34"/>
                    </a:lnTo>
                    <a:lnTo>
                      <a:pt x="8494" y="0"/>
                    </a:lnTo>
                    <a:lnTo>
                      <a:pt x="8500" y="0"/>
                    </a:lnTo>
                    <a:close/>
                    <a:moveTo>
                      <a:pt x="8854" y="0"/>
                    </a:moveTo>
                    <a:lnTo>
                      <a:pt x="8854" y="34"/>
                    </a:lnTo>
                    <a:lnTo>
                      <a:pt x="8848" y="34"/>
                    </a:lnTo>
                    <a:lnTo>
                      <a:pt x="8848" y="0"/>
                    </a:lnTo>
                    <a:lnTo>
                      <a:pt x="8854" y="0"/>
                    </a:lnTo>
                    <a:close/>
                    <a:moveTo>
                      <a:pt x="9208" y="0"/>
                    </a:moveTo>
                    <a:lnTo>
                      <a:pt x="9208" y="34"/>
                    </a:lnTo>
                    <a:lnTo>
                      <a:pt x="9203" y="34"/>
                    </a:lnTo>
                    <a:lnTo>
                      <a:pt x="9203" y="0"/>
                    </a:lnTo>
                    <a:lnTo>
                      <a:pt x="9208" y="0"/>
                    </a:lnTo>
                    <a:close/>
                    <a:moveTo>
                      <a:pt x="9562" y="0"/>
                    </a:moveTo>
                    <a:lnTo>
                      <a:pt x="9562" y="34"/>
                    </a:lnTo>
                    <a:lnTo>
                      <a:pt x="9556" y="34"/>
                    </a:lnTo>
                    <a:lnTo>
                      <a:pt x="9556" y="0"/>
                    </a:lnTo>
                    <a:lnTo>
                      <a:pt x="9562" y="0"/>
                    </a:lnTo>
                    <a:close/>
                    <a:moveTo>
                      <a:pt x="9916" y="0"/>
                    </a:moveTo>
                    <a:lnTo>
                      <a:pt x="9916" y="34"/>
                    </a:lnTo>
                    <a:lnTo>
                      <a:pt x="9910" y="34"/>
                    </a:lnTo>
                    <a:lnTo>
                      <a:pt x="9910" y="0"/>
                    </a:lnTo>
                    <a:lnTo>
                      <a:pt x="9916" y="0"/>
                    </a:lnTo>
                    <a:close/>
                    <a:moveTo>
                      <a:pt x="10270" y="0"/>
                    </a:moveTo>
                    <a:lnTo>
                      <a:pt x="10270" y="34"/>
                    </a:lnTo>
                    <a:lnTo>
                      <a:pt x="10264" y="34"/>
                    </a:lnTo>
                    <a:lnTo>
                      <a:pt x="10264" y="0"/>
                    </a:lnTo>
                    <a:lnTo>
                      <a:pt x="1027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9" name="Rectangle 68"/>
              <p:cNvSpPr>
                <a:spLocks noChangeArrowheads="1"/>
              </p:cNvSpPr>
              <p:nvPr/>
            </p:nvSpPr>
            <p:spPr bwMode="auto">
              <a:xfrm>
                <a:off x="424085" y="1898338"/>
                <a:ext cx="53664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4,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0" name="Rectangle 69"/>
              <p:cNvSpPr>
                <a:spLocks noChangeArrowheads="1"/>
              </p:cNvSpPr>
              <p:nvPr/>
            </p:nvSpPr>
            <p:spPr bwMode="auto">
              <a:xfrm>
                <a:off x="424085" y="1631066"/>
                <a:ext cx="53664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8,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1" name="Rectangle 70"/>
              <p:cNvSpPr>
                <a:spLocks noChangeArrowheads="1"/>
              </p:cNvSpPr>
              <p:nvPr/>
            </p:nvSpPr>
            <p:spPr bwMode="auto">
              <a:xfrm>
                <a:off x="381000" y="1363793"/>
                <a:ext cx="62932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2,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2" name="Rectangle 71"/>
              <p:cNvSpPr>
                <a:spLocks noChangeArrowheads="1"/>
              </p:cNvSpPr>
              <p:nvPr/>
            </p:nvSpPr>
            <p:spPr bwMode="auto">
              <a:xfrm>
                <a:off x="381000" y="1096520"/>
                <a:ext cx="62932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6,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3" name="Rectangle 72"/>
              <p:cNvSpPr>
                <a:spLocks noChangeArrowheads="1"/>
              </p:cNvSpPr>
              <p:nvPr/>
            </p:nvSpPr>
            <p:spPr bwMode="auto">
              <a:xfrm>
                <a:off x="381000" y="829247"/>
                <a:ext cx="62932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0,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4" name="Rectangle 73"/>
              <p:cNvSpPr>
                <a:spLocks noChangeArrowheads="1"/>
              </p:cNvSpPr>
              <p:nvPr/>
            </p:nvSpPr>
            <p:spPr bwMode="auto">
              <a:xfrm>
                <a:off x="381000" y="561975"/>
                <a:ext cx="62932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24,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6" name="Rectangle 16"/>
              <p:cNvSpPr>
                <a:spLocks noChangeArrowheads="1"/>
              </p:cNvSpPr>
              <p:nvPr/>
            </p:nvSpPr>
            <p:spPr bwMode="auto">
              <a:xfrm>
                <a:off x="380155" y="2115979"/>
                <a:ext cx="66759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,000</a:t>
                </a:r>
                <a:endParaRPr kumimoji="0" lang="en-US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4202" name="Picture 10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83258" y="4343400"/>
              <a:ext cx="3697778" cy="20883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6" name="Group 96"/>
            <p:cNvGrpSpPr/>
            <p:nvPr/>
          </p:nvGrpSpPr>
          <p:grpSpPr>
            <a:xfrm>
              <a:off x="5703308" y="4343400"/>
              <a:ext cx="1535692" cy="2057400"/>
              <a:chOff x="7040413" y="4343400"/>
              <a:chExt cx="1535692" cy="2057400"/>
            </a:xfrm>
          </p:grpSpPr>
          <p:pic>
            <p:nvPicPr>
              <p:cNvPr id="4177" name="Picture 4176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32882" t="30062" r="39925"/>
              <a:stretch/>
            </p:blipFill>
            <p:spPr>
              <a:xfrm>
                <a:off x="7040413" y="4357877"/>
                <a:ext cx="1535692" cy="204292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7" name="TextBox 186"/>
              <p:cNvSpPr txBox="1"/>
              <p:nvPr/>
            </p:nvSpPr>
            <p:spPr>
              <a:xfrm>
                <a:off x="7841533" y="5191642"/>
                <a:ext cx="575799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Alpha</a:t>
                </a:r>
              </a:p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8" name="TextBox 187"/>
              <p:cNvSpPr txBox="1"/>
              <p:nvPr/>
            </p:nvSpPr>
            <p:spPr>
              <a:xfrm>
                <a:off x="7771595" y="4343400"/>
                <a:ext cx="762804" cy="24257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Peptide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89" name="Straight Arrow Connector 188"/>
              <p:cNvCxnSpPr/>
              <p:nvPr/>
            </p:nvCxnSpPr>
            <p:spPr>
              <a:xfrm>
                <a:off x="7848599" y="4413845"/>
                <a:ext cx="0" cy="15815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" name="TextBox 189"/>
              <p:cNvSpPr txBox="1"/>
              <p:nvPr/>
            </p:nvSpPr>
            <p:spPr>
              <a:xfrm>
                <a:off x="7318604" y="5461300"/>
                <a:ext cx="550151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Beta</a:t>
                </a:r>
              </a:p>
              <a:p>
                <a:pPr algn="ctr"/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chain</a:t>
                </a:r>
                <a:endParaRPr lang="en-US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>
                <a:off x="7300688" y="4546461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bg1"/>
                    </a:solidFill>
                    <a:latin typeface="Arial" pitchFamily="34" charset="0"/>
                    <a:cs typeface="Arial" pitchFamily="34" charset="0"/>
                  </a:rPr>
                  <a:t>55P</a:t>
                </a:r>
                <a:endParaRPr lang="en-US" sz="12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3" name="TextBox 92"/>
            <p:cNvSpPr txBox="1"/>
            <p:nvPr/>
          </p:nvSpPr>
          <p:spPr>
            <a:xfrm>
              <a:off x="3202036" y="3990201"/>
              <a:ext cx="3109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HLA DQ Single Antigen beads specificitie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-995567" y="1211255"/>
              <a:ext cx="24513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Fluorescence Intensity (MFI)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-46166"/>
            <a:ext cx="91440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N.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2006 shared by DQB1*03:01 (DQ7), DQB1*03:02 (DQ8), DQB1*03:03 (DQ9) and defined by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Prolin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(P) at position 55 on the beta chains of the DQ antigens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1859262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9</Words>
  <Application>Microsoft Office PowerPoint</Application>
  <PresentationFormat>On-screen Show (4:3)</PresentationFormat>
  <Paragraphs>8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38:07Z</dcterms:created>
  <dcterms:modified xsi:type="dcterms:W3CDTF">2017-03-12T04:39:40Z</dcterms:modified>
</cp:coreProperties>
</file>